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sldIdLst>
    <p:sldId id="270" r:id="rId2"/>
    <p:sldId id="271" r:id="rId3"/>
    <p:sldId id="272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40" d="100"/>
          <a:sy n="40" d="100"/>
        </p:scale>
        <p:origin x="-4164" y="-124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E0D1A-2D01-4481-A1A6-CBFD70591189}" type="datetimeFigureOut">
              <a:rPr lang="en-US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D24AB-8760-4D56-BFEE-4D2DF63ADB2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 descr="C:\Users\F.NISAR.FARRUKH\Desktop\WangMei et al., 2017. OX Med Cell Long\R.1, Wang Mei et al., 2017, 08.11\SF 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4290" y="250830"/>
            <a:ext cx="6459040" cy="9131326"/>
          </a:xfrm>
          <a:prstGeom prst="rect">
            <a:avLst/>
          </a:prstGeom>
          <a:noFill/>
        </p:spPr>
      </p:pic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7810520"/>
            <a:ext cx="6858000" cy="64633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pplementary Fig. 1 Co-treatment inhibited Ki67 expression.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Microsoft YaHei" pitchFamily="34" charset="-122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Immunofluorescen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 assay was used to analyze cell proliferation marker Ki67 and its expression in UVA and BR treated cells for 48 hours.</a:t>
            </a:r>
            <a:r>
              <a:rPr kumimoji="0" lang="en-GB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 descr="C:\Users\F.NISAR.FARRUKH\Desktop\WangMei et al., 2017. OX Med Cell Long\R.1, Wang Mei et al., 2017, 08.11\SF 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1414" y="202703"/>
            <a:ext cx="6711698" cy="9488517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357166" y="7521379"/>
            <a:ext cx="6143668" cy="64633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pplementary Fig. 2 Co-treatment has no effect on keratinocyte apoptosis.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Microsoft YaHei" pitchFamily="34" charset="-122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(A and B) Keratinocyte HaCaT were treated with UVA and BR for 24 hours before measuring apoptosis using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Annexi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 V and PI in conjunction with flow cytometry.</a:t>
            </a:r>
            <a:r>
              <a:rPr kumimoji="0" lang="en-GB" altLang="zh-CN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GB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 descr="C:\Users\F.NISAR.FARRUKH\Desktop\WangMei et al., 2017. OX Med Cell Long\R.1, Wang Mei et al., 2017, 08.11\SF 3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5041" y="233692"/>
            <a:ext cx="6429420" cy="9089451"/>
          </a:xfrm>
          <a:prstGeom prst="rect">
            <a:avLst/>
          </a:prstGeom>
          <a:noFill/>
        </p:spPr>
      </p:pic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285728" y="7381892"/>
            <a:ext cx="6215106" cy="101566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pplementary Fig. 3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UVA irradiation inhibited Nrf2</a:t>
            </a:r>
            <a:r>
              <a:rPr kumimoji="0" lang="en-US" altLang="zh-CN" sz="12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-/-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#1 A375 cells proliferation.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Microsoft YaHei" pitchFamily="34" charset="-122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(A) A375 Nrf2</a:t>
            </a:r>
            <a:r>
              <a:rPr kumimoji="0" lang="en-US" altLang="zh-CN" sz="12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-/-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#1</a:t>
            </a:r>
            <a:r>
              <a:rPr kumimoji="0" lang="en-US" altLang="zh-CN" sz="12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irradiated with 75 KJ/m</a:t>
            </a:r>
            <a:r>
              <a:rPr kumimoji="0" lang="en-US" altLang="zh-CN" sz="12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2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 UVA, followed by MTS assay. (B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)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cell cycle related genes cyclinE2, CDK4 and CDK6 were performed by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qRT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Microsoft YaHei" pitchFamily="34" charset="-122"/>
                <a:cs typeface="Times New Roman" pitchFamily="18" charset="0"/>
              </a:rPr>
              <a:t>-PCR assay. (C) Colony formation was examined by staining colonies with crystal violet. Colonies with more than 50 cells were counted (n=3).</a:t>
            </a:r>
            <a:r>
              <a:rPr kumimoji="0" lang="en-GB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50</Words>
  <Application>Microsoft Office PowerPoint</Application>
  <PresentationFormat>A4 Paper (210x297 mm)</PresentationFormat>
  <Paragraphs>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.NISAR</dc:creator>
  <cp:lastModifiedBy>sysadmin</cp:lastModifiedBy>
  <cp:revision>10</cp:revision>
  <dcterms:created xsi:type="dcterms:W3CDTF">2017-05-15T21:33:19Z</dcterms:created>
  <dcterms:modified xsi:type="dcterms:W3CDTF">2017-11-12T08:51:11Z</dcterms:modified>
</cp:coreProperties>
</file>